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264275" cy="104394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8" userDrawn="1">
          <p15:clr>
            <a:srgbClr val="A4A3A4"/>
          </p15:clr>
        </p15:guide>
        <p15:guide id="2" pos="1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2166" y="-1968"/>
      </p:cViewPr>
      <p:guideLst>
        <p:guide orient="horz" pos="3288"/>
        <p:guide pos="1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708486"/>
            <a:ext cx="5324634" cy="363445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5483102"/>
            <a:ext cx="4698206" cy="2520438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1" indent="0" algn="ctr">
              <a:buNone/>
              <a:defRPr sz="1370"/>
            </a:lvl2pPr>
            <a:lvl3pPr marL="626442" indent="0" algn="ctr">
              <a:buNone/>
              <a:defRPr sz="1234"/>
            </a:lvl3pPr>
            <a:lvl4pPr marL="939663" indent="0" algn="ctr">
              <a:buNone/>
              <a:defRPr sz="1096"/>
            </a:lvl4pPr>
            <a:lvl5pPr marL="1252883" indent="0" algn="ctr">
              <a:buNone/>
              <a:defRPr sz="1096"/>
            </a:lvl5pPr>
            <a:lvl6pPr marL="1566104" indent="0" algn="ctr">
              <a:buNone/>
              <a:defRPr sz="1096"/>
            </a:lvl6pPr>
            <a:lvl7pPr marL="1879325" indent="0" algn="ctr">
              <a:buNone/>
              <a:defRPr sz="1096"/>
            </a:lvl7pPr>
            <a:lvl8pPr marL="2192546" indent="0" algn="ctr">
              <a:buNone/>
              <a:defRPr sz="1096"/>
            </a:lvl8pPr>
            <a:lvl9pPr marL="2505767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69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44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555802"/>
            <a:ext cx="1350734" cy="8846909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71" y="555802"/>
            <a:ext cx="3973899" cy="8846909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713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19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9" y="2602603"/>
            <a:ext cx="5402937" cy="4342500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9" y="6986187"/>
            <a:ext cx="5402937" cy="2283617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1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42" indent="0">
              <a:buNone/>
              <a:defRPr sz="1234">
                <a:solidFill>
                  <a:schemeClr val="tx1">
                    <a:tint val="75000"/>
                  </a:schemeClr>
                </a:solidFill>
              </a:defRPr>
            </a:lvl3pPr>
            <a:lvl4pPr marL="93966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8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0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25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4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767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3680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71" y="2779008"/>
            <a:ext cx="2662317" cy="662370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91" y="2779008"/>
            <a:ext cx="2662317" cy="662370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755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7" y="555805"/>
            <a:ext cx="5402937" cy="201780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559105"/>
            <a:ext cx="2650082" cy="1254177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1" indent="0">
              <a:buNone/>
              <a:defRPr sz="1370" b="1"/>
            </a:lvl2pPr>
            <a:lvl3pPr marL="626442" indent="0">
              <a:buNone/>
              <a:defRPr sz="1234" b="1"/>
            </a:lvl3pPr>
            <a:lvl4pPr marL="939663" indent="0">
              <a:buNone/>
              <a:defRPr sz="1096" b="1"/>
            </a:lvl4pPr>
            <a:lvl5pPr marL="1252883" indent="0">
              <a:buNone/>
              <a:defRPr sz="1096" b="1"/>
            </a:lvl5pPr>
            <a:lvl6pPr marL="1566104" indent="0">
              <a:buNone/>
              <a:defRPr sz="1096" b="1"/>
            </a:lvl6pPr>
            <a:lvl7pPr marL="1879325" indent="0">
              <a:buNone/>
              <a:defRPr sz="1096" b="1"/>
            </a:lvl7pPr>
            <a:lvl8pPr marL="2192546" indent="0">
              <a:buNone/>
              <a:defRPr sz="1096" b="1"/>
            </a:lvl8pPr>
            <a:lvl9pPr marL="2505767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813281"/>
            <a:ext cx="2650082" cy="56087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91" y="2559105"/>
            <a:ext cx="2663133" cy="1254177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1" indent="0">
              <a:buNone/>
              <a:defRPr sz="1370" b="1"/>
            </a:lvl2pPr>
            <a:lvl3pPr marL="626442" indent="0">
              <a:buNone/>
              <a:defRPr sz="1234" b="1"/>
            </a:lvl3pPr>
            <a:lvl4pPr marL="939663" indent="0">
              <a:buNone/>
              <a:defRPr sz="1096" b="1"/>
            </a:lvl4pPr>
            <a:lvl5pPr marL="1252883" indent="0">
              <a:buNone/>
              <a:defRPr sz="1096" b="1"/>
            </a:lvl5pPr>
            <a:lvl6pPr marL="1566104" indent="0">
              <a:buNone/>
              <a:defRPr sz="1096" b="1"/>
            </a:lvl6pPr>
            <a:lvl7pPr marL="1879325" indent="0">
              <a:buNone/>
              <a:defRPr sz="1096" b="1"/>
            </a:lvl7pPr>
            <a:lvl8pPr marL="2192546" indent="0">
              <a:buNone/>
              <a:defRPr sz="1096" b="1"/>
            </a:lvl8pPr>
            <a:lvl9pPr marL="2505767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91" y="3813281"/>
            <a:ext cx="2663133" cy="56087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9201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881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413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695960"/>
            <a:ext cx="2020392" cy="243586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5" y="1503084"/>
            <a:ext cx="3171289" cy="7418740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3131820"/>
            <a:ext cx="2020392" cy="5802084"/>
          </a:xfrm>
        </p:spPr>
        <p:txBody>
          <a:bodyPr/>
          <a:lstStyle>
            <a:lvl1pPr marL="0" indent="0">
              <a:buNone/>
              <a:defRPr sz="1096"/>
            </a:lvl1pPr>
            <a:lvl2pPr marL="313221" indent="0">
              <a:buNone/>
              <a:defRPr sz="959"/>
            </a:lvl2pPr>
            <a:lvl3pPr marL="626442" indent="0">
              <a:buNone/>
              <a:defRPr sz="822"/>
            </a:lvl3pPr>
            <a:lvl4pPr marL="939663" indent="0">
              <a:buNone/>
              <a:defRPr sz="685"/>
            </a:lvl4pPr>
            <a:lvl5pPr marL="1252883" indent="0">
              <a:buNone/>
              <a:defRPr sz="685"/>
            </a:lvl5pPr>
            <a:lvl6pPr marL="1566104" indent="0">
              <a:buNone/>
              <a:defRPr sz="685"/>
            </a:lvl6pPr>
            <a:lvl7pPr marL="1879325" indent="0">
              <a:buNone/>
              <a:defRPr sz="685"/>
            </a:lvl7pPr>
            <a:lvl8pPr marL="2192546" indent="0">
              <a:buNone/>
              <a:defRPr sz="685"/>
            </a:lvl8pPr>
            <a:lvl9pPr marL="2505767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546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695960"/>
            <a:ext cx="2020392" cy="243586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5" y="1503084"/>
            <a:ext cx="3171289" cy="7418740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1" indent="0">
              <a:buNone/>
              <a:defRPr sz="1918"/>
            </a:lvl2pPr>
            <a:lvl3pPr marL="626442" indent="0">
              <a:buNone/>
              <a:defRPr sz="1644"/>
            </a:lvl3pPr>
            <a:lvl4pPr marL="939663" indent="0">
              <a:buNone/>
              <a:defRPr sz="1370"/>
            </a:lvl4pPr>
            <a:lvl5pPr marL="1252883" indent="0">
              <a:buNone/>
              <a:defRPr sz="1370"/>
            </a:lvl5pPr>
            <a:lvl6pPr marL="1566104" indent="0">
              <a:buNone/>
              <a:defRPr sz="1370"/>
            </a:lvl6pPr>
            <a:lvl7pPr marL="1879325" indent="0">
              <a:buNone/>
              <a:defRPr sz="1370"/>
            </a:lvl7pPr>
            <a:lvl8pPr marL="2192546" indent="0">
              <a:buNone/>
              <a:defRPr sz="1370"/>
            </a:lvl8pPr>
            <a:lvl9pPr marL="2505767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3131820"/>
            <a:ext cx="2020392" cy="5802084"/>
          </a:xfrm>
        </p:spPr>
        <p:txBody>
          <a:bodyPr/>
          <a:lstStyle>
            <a:lvl1pPr marL="0" indent="0">
              <a:buNone/>
              <a:defRPr sz="1096"/>
            </a:lvl1pPr>
            <a:lvl2pPr marL="313221" indent="0">
              <a:buNone/>
              <a:defRPr sz="959"/>
            </a:lvl2pPr>
            <a:lvl3pPr marL="626442" indent="0">
              <a:buNone/>
              <a:defRPr sz="822"/>
            </a:lvl3pPr>
            <a:lvl4pPr marL="939663" indent="0">
              <a:buNone/>
              <a:defRPr sz="685"/>
            </a:lvl4pPr>
            <a:lvl5pPr marL="1252883" indent="0">
              <a:buNone/>
              <a:defRPr sz="685"/>
            </a:lvl5pPr>
            <a:lvl6pPr marL="1566104" indent="0">
              <a:buNone/>
              <a:defRPr sz="685"/>
            </a:lvl6pPr>
            <a:lvl7pPr marL="1879325" indent="0">
              <a:buNone/>
              <a:defRPr sz="685"/>
            </a:lvl7pPr>
            <a:lvl8pPr marL="2192546" indent="0">
              <a:buNone/>
              <a:defRPr sz="685"/>
            </a:lvl8pPr>
            <a:lvl9pPr marL="2505767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938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555805"/>
            <a:ext cx="5402937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779008"/>
            <a:ext cx="5402937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9675780"/>
            <a:ext cx="1409462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9675780"/>
            <a:ext cx="2114193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9675780"/>
            <a:ext cx="1409462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789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6442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0" indent="-156610" algn="l" defTabSz="626442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31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52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73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4pPr>
      <a:lvl5pPr marL="1409494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5pPr>
      <a:lvl6pPr marL="1722714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6pPr>
      <a:lvl7pPr marL="2035936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7pPr>
      <a:lvl8pPr marL="2349156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8pPr>
      <a:lvl9pPr marL="2662377" indent="-156610" algn="l" defTabSz="626442" rtl="0" eaLnBrk="1" latinLnBrk="0" hangingPunct="1">
        <a:lnSpc>
          <a:spcPct val="90000"/>
        </a:lnSpc>
        <a:spcBef>
          <a:spcPts val="344"/>
        </a:spcBef>
        <a:buFont typeface="Arial" panose="020B0604020202020204" pitchFamily="34" charset="0"/>
        <a:buChar char="•"/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1pPr>
      <a:lvl2pPr marL="313221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2pPr>
      <a:lvl3pPr marL="626442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3pPr>
      <a:lvl4pPr marL="939663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4pPr>
      <a:lvl5pPr marL="1252883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5pPr>
      <a:lvl6pPr marL="1566104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6pPr>
      <a:lvl7pPr marL="1879325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7pPr>
      <a:lvl8pPr marL="2192546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8pPr>
      <a:lvl9pPr marL="2505767" algn="l" defTabSz="626442" rtl="0" eaLnBrk="1" latinLnBrk="0" hangingPunct="1">
        <a:defRPr kumimoji="1" sz="12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269" y="727281"/>
            <a:ext cx="6027495" cy="6248953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360370" y="166662"/>
            <a:ext cx="5764720" cy="828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063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</a:t>
            </a:r>
            <a:r>
              <a:rPr lang="en-US" altLang="ja-JP" sz="1063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</a:t>
            </a:r>
          </a:p>
          <a:p>
            <a:pPr>
              <a:lnSpc>
                <a:spcPct val="150000"/>
              </a:lnSpc>
            </a:pPr>
            <a:r>
              <a:rPr lang="en-US" altLang="ja-JP" sz="1063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atterplot matrix of the MAFs in the current datasets and different ethnicity datasets for the </a:t>
            </a:r>
          </a:p>
          <a:p>
            <a:pPr>
              <a:lnSpc>
                <a:spcPct val="150000"/>
              </a:lnSpc>
            </a:pPr>
            <a:r>
              <a:rPr lang="en-US" altLang="ja-JP" sz="1063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NPs selected by STMGP</a:t>
            </a:r>
            <a:endParaRPr lang="ja-JP" altLang="en-US" sz="1063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199486" y="7158903"/>
            <a:ext cx="588138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bbreviations: MAF, minor allele frequency; STMGP, Smooth-Threshold Multivariate Genetic Prediction; EAS, East Asian; AMR, Latino; FIN, Finnish; AFR, African/African American; NFE, Non-Finnish European; ASJ, Ashkenazi Jewish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209397" y="7792059"/>
            <a:ext cx="588138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 MAFs in the current datasets were strongly correlated with the MAFs in the East Asian ethnic group (r2 =0.928), and most of the SNPs were not specific to the Japanese population except rs1774414 (the MAF in the current datasets was 0.2458 and the MAFs in the ethnic groups in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nomAD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1, including East Asian, were less than 0.02, while the MAF was 0.217 in the 1000 Genomes project 2, 3 with the MAF of 0.327 for the East Asian group).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199486" y="8777636"/>
            <a:ext cx="588138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eferenece</a:t>
            </a:r>
            <a:endParaRPr lang="en-US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arczewski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KJ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rancioli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LC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iao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G, Cummings BB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földi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J, Wang Q, et al. Variation across 141,456 human exomes and genomes reveals the spectrum of loss-of-function intolerance across human protein-coding genes.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ioRxiv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2019: 531210.</a:t>
            </a:r>
          </a:p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.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uton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, Brooks LD, Durbin RM, Garrison EP, Kang HM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orbel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JO, et al. A global reference for human genetic variation. Nature 2015; 526(7571): 68-74.</a:t>
            </a:r>
          </a:p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3.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dmant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PH, Rausch T, Gardner EJ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ndsaker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RE, </a:t>
            </a:r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byzov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, Huddleston J, et al. An integrated map of structural variation in 2,504 human genomes. Nature 2015; 526(7571): 75-81.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135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</TotalTime>
  <Words>280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12</cp:revision>
  <dcterms:created xsi:type="dcterms:W3CDTF">2019-06-03T06:47:50Z</dcterms:created>
  <dcterms:modified xsi:type="dcterms:W3CDTF">2020-08-06T03:50:31Z</dcterms:modified>
</cp:coreProperties>
</file>